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4" r:id="rId3"/>
    <p:sldId id="265" r:id="rId4"/>
    <p:sldId id="266" r:id="rId5"/>
    <p:sldId id="263" r:id="rId6"/>
    <p:sldId id="267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626"/>
  </p:normalViewPr>
  <p:slideViewPr>
    <p:cSldViewPr snapToGrid="0" snapToObjects="1">
      <p:cViewPr varScale="1">
        <p:scale>
          <a:sx n="121" d="100"/>
          <a:sy n="121" d="100"/>
        </p:scale>
        <p:origin x="74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3A0098-3728-F865-B281-7F5DE80BF89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EC8C290-D826-04FB-103B-46F81895834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F520B3-893E-C450-F3FC-865037E5A1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9CFF-459D-314F-8429-DCFC2FA3514C}" type="datetimeFigureOut">
              <a:rPr lang="en-US" smtClean="0"/>
              <a:t>7/2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2D4FEF-4C6A-CF09-A7E6-7E2EE2ACF9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33DAAF-6419-D41C-9538-551BC358A3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21D79-1576-2346-AA63-BBFE11FC99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217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CD9FF2-CDD4-10F7-A382-D4AA85F5C4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BAF5ED-768B-B161-89CD-00E055D84F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1BAAF7-30A2-F0AE-41BB-64264C7F83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9CFF-459D-314F-8429-DCFC2FA3514C}" type="datetimeFigureOut">
              <a:rPr lang="en-US" smtClean="0"/>
              <a:t>7/2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CC6949-6009-7CBE-16F1-97B3083E06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0EF06E-809C-E5A3-4E74-5C8F2EBA2A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21D79-1576-2346-AA63-BBFE11FC99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66061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0DE942E-63A4-03CF-E139-31EB464053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CDAD62F-9362-9E3B-9178-6D43262B18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6B45FB-3663-FA9D-D186-3529006D50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9CFF-459D-314F-8429-DCFC2FA3514C}" type="datetimeFigureOut">
              <a:rPr lang="en-US" smtClean="0"/>
              <a:t>7/2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B81384-3207-9E84-0886-C94230CD04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CC3D69-B13C-79CE-FF0C-32D0CF8822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21D79-1576-2346-AA63-BBFE11FC99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2064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6FEA7C-D4DC-1520-ABDA-0912EA388E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8A1A61-0445-44A0-EC6A-1800D4C66AA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F0F74D-2581-F7B4-5A5B-6DE77F534A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9CFF-459D-314F-8429-DCFC2FA3514C}" type="datetimeFigureOut">
              <a:rPr lang="en-US" smtClean="0"/>
              <a:t>7/2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126F79-48C8-5B96-A475-1837ED8787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3D7400-2A18-2090-FF22-415C35E9C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21D79-1576-2346-AA63-BBFE11FC99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38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EA3C6C-7498-CAD0-0B4A-C2BF586F00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4BC757-B976-F265-4FB3-5399CCAC68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371226-292A-CFC3-32C3-95926FED1E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9CFF-459D-314F-8429-DCFC2FA3514C}" type="datetimeFigureOut">
              <a:rPr lang="en-US" smtClean="0"/>
              <a:t>7/2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999F4F-3319-FC23-9EF0-BDCE478D6D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23656B-19DF-2AB3-913E-582161B63D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21D79-1576-2346-AA63-BBFE11FC99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847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123838-10B8-3CFB-AC56-483A934A37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CF6FCC-E79D-659C-0309-6F3FD7BDD9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10FE0D-8453-28BD-0267-8ABEFA2928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F4B417-BEEC-62C4-13BC-04526B608A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9CFF-459D-314F-8429-DCFC2FA3514C}" type="datetimeFigureOut">
              <a:rPr lang="en-US" smtClean="0"/>
              <a:t>7/22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BFB2ED-BEA0-9C6A-A4CF-97EB99DF60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586A99-AD02-12F4-CC23-5BDD379233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21D79-1576-2346-AA63-BBFE11FC99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2937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C930D8-34D1-2689-6AF2-E8CF6D4FDF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9B0815-6F77-D53B-AC91-091A3F5B9C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4DAD83-C251-91C2-9046-27EFC0681B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BFCA3D3-D528-CDC8-5BCD-103B865A63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C7A5738-624A-65A3-078D-292AF866549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EBAA91D-A849-E34E-389B-E6974E54A9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9CFF-459D-314F-8429-DCFC2FA3514C}" type="datetimeFigureOut">
              <a:rPr lang="en-US" smtClean="0"/>
              <a:t>7/22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CC416FB-0BFE-642A-9EA4-358FDA3489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A5311AF-CE8D-0D45-C69F-E58DF4CAA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21D79-1576-2346-AA63-BBFE11FC99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186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F7B5BB-1EC6-586D-CE48-DFA1C0D799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5EAECC3-1498-DB11-FA70-68A37463B7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9CFF-459D-314F-8429-DCFC2FA3514C}" type="datetimeFigureOut">
              <a:rPr lang="en-US" smtClean="0"/>
              <a:t>7/22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14C2514-B9A0-D140-12CE-A13C4FEFB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8754ABC-3C86-2E4C-EC3F-B6D4F959A1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21D79-1576-2346-AA63-BBFE11FC99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519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CA6E0D5-1A68-3012-8737-49D3399D77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9CFF-459D-314F-8429-DCFC2FA3514C}" type="datetimeFigureOut">
              <a:rPr lang="en-US" smtClean="0"/>
              <a:t>7/22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4F18E0C-2C07-932E-9C33-0B099976A7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D8362F3-1B31-A7A3-0B7F-902DAAFD4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21D79-1576-2346-AA63-BBFE11FC99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2829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A9EED7-836A-BFA3-D380-8158C9CFA9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CF9512-92FE-BDAA-6DB9-D4D720209CB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D815B00-BBC6-ABF1-0A6F-AE4716DB87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8877C4-99F2-CC83-A5BA-429313807B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9CFF-459D-314F-8429-DCFC2FA3514C}" type="datetimeFigureOut">
              <a:rPr lang="en-US" smtClean="0"/>
              <a:t>7/22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8F32C1-E7B2-9C43-FEAC-77E877EF95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189687-3A50-D038-0E08-9CA369F7A8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21D79-1576-2346-AA63-BBFE11FC99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252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BB739C-D73D-C53C-FE39-3D702B103C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08A2E18-7D24-6A06-BAFF-4A1D8F5CD34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AA9019-E2DC-5D07-B73B-4AAA2F21DA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EA7CA5-277C-AC18-1AFD-6BE6F1423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9CFF-459D-314F-8429-DCFC2FA3514C}" type="datetimeFigureOut">
              <a:rPr lang="en-US" smtClean="0"/>
              <a:t>7/22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3B776B-2E4B-73A2-B87F-19587139C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FACA00-F633-5F4B-8A3A-B182BDAD66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21D79-1576-2346-AA63-BBFE11FC99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3223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D81E269-641B-B2AE-3A22-08AD787B3C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FFABF7-4F6F-1BBA-9346-A952305DA9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2BE87F-449A-F2E5-84CB-8F39F29B41E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3A9CFF-459D-314F-8429-DCFC2FA3514C}" type="datetimeFigureOut">
              <a:rPr lang="en-US" smtClean="0"/>
              <a:t>7/2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665646-890E-A631-28B1-CED313316E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BF2169-C0B0-4CAC-B8F1-1F2923B0AED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21D79-1576-2346-AA63-BBFE11FC99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089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EBF6FDC-E756-004F-EDA1-1F9D182A82F2}"/>
              </a:ext>
            </a:extLst>
          </p:cNvPr>
          <p:cNvSpPr txBox="1"/>
          <p:nvPr/>
        </p:nvSpPr>
        <p:spPr>
          <a:xfrm>
            <a:off x="4243666" y="214360"/>
            <a:ext cx="5597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Western Blot Image for Figure 1B (</a:t>
            </a:r>
            <a:r>
              <a:rPr lang="en-US" dirty="0" err="1"/>
              <a:t>eNOS</a:t>
            </a:r>
            <a:r>
              <a:rPr lang="en-US" dirty="0"/>
              <a:t> and GAPDH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FC5379D-53EB-578B-8105-B4E5494EC3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3643" y="804041"/>
            <a:ext cx="8394700" cy="4724400"/>
          </a:xfrm>
          <a:prstGeom prst="rect">
            <a:avLst/>
          </a:prstGeom>
        </p:spPr>
      </p:pic>
      <p:sp>
        <p:nvSpPr>
          <p:cNvPr id="18" name="Right Bracket 17">
            <a:extLst>
              <a:ext uri="{FF2B5EF4-FFF2-40B4-BE49-F238E27FC236}">
                <a16:creationId xmlns:a16="http://schemas.microsoft.com/office/drawing/2014/main" id="{772560B0-9D9B-01CD-8269-26155857417C}"/>
              </a:ext>
            </a:extLst>
          </p:cNvPr>
          <p:cNvSpPr/>
          <p:nvPr/>
        </p:nvSpPr>
        <p:spPr>
          <a:xfrm rot="5400000">
            <a:off x="3761910" y="2659908"/>
            <a:ext cx="130535" cy="1032843"/>
          </a:xfrm>
          <a:prstGeom prst="righ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ight Bracket 18">
            <a:extLst>
              <a:ext uri="{FF2B5EF4-FFF2-40B4-BE49-F238E27FC236}">
                <a16:creationId xmlns:a16="http://schemas.microsoft.com/office/drawing/2014/main" id="{E42A5673-58F5-446E-DC89-65C4C6DF676F}"/>
              </a:ext>
            </a:extLst>
          </p:cNvPr>
          <p:cNvSpPr/>
          <p:nvPr/>
        </p:nvSpPr>
        <p:spPr>
          <a:xfrm rot="5400000">
            <a:off x="7619998" y="1975944"/>
            <a:ext cx="141889" cy="972209"/>
          </a:xfrm>
          <a:prstGeom prst="righ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E9A5CE0-1C58-EBA9-20AE-8AE3C3D1B693}"/>
              </a:ext>
            </a:extLst>
          </p:cNvPr>
          <p:cNvSpPr txBox="1"/>
          <p:nvPr/>
        </p:nvSpPr>
        <p:spPr>
          <a:xfrm>
            <a:off x="3497599" y="3312964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se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27890E7-4FBE-DCCE-F13C-3CE80773018F}"/>
              </a:ext>
            </a:extLst>
          </p:cNvPr>
          <p:cNvSpPr txBox="1"/>
          <p:nvPr/>
        </p:nvSpPr>
        <p:spPr>
          <a:xfrm>
            <a:off x="7320534" y="2604360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sed</a:t>
            </a:r>
          </a:p>
        </p:txBody>
      </p:sp>
    </p:spTree>
    <p:extLst>
      <p:ext uri="{BB962C8B-B14F-4D97-AF65-F5344CB8AC3E}">
        <p14:creationId xmlns:p14="http://schemas.microsoft.com/office/powerpoint/2010/main" val="15941028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CA2F6D2-24A6-B8FA-C026-F550346B3820}"/>
              </a:ext>
            </a:extLst>
          </p:cNvPr>
          <p:cNvSpPr txBox="1"/>
          <p:nvPr/>
        </p:nvSpPr>
        <p:spPr>
          <a:xfrm>
            <a:off x="4227988" y="178676"/>
            <a:ext cx="57862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Western Blot Image for Figure 1F (Ki67, p21 and GAPH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06EEDA0-B989-1BE0-C252-10D216BD22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31529" y="548008"/>
            <a:ext cx="4000500" cy="46228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A2990BB0-476F-E791-9DAC-BDD7862FC86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00499" y="624646"/>
            <a:ext cx="4191000" cy="45593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2E6D98E-0132-72FB-6327-E4A44D75560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13549" y="777484"/>
            <a:ext cx="4025900" cy="4483100"/>
          </a:xfrm>
          <a:prstGeom prst="rect">
            <a:avLst/>
          </a:prstGeom>
        </p:spPr>
      </p:pic>
      <p:sp>
        <p:nvSpPr>
          <p:cNvPr id="6" name="Right Bracket 5">
            <a:extLst>
              <a:ext uri="{FF2B5EF4-FFF2-40B4-BE49-F238E27FC236}">
                <a16:creationId xmlns:a16="http://schemas.microsoft.com/office/drawing/2014/main" id="{8DFEE486-08D7-ED97-F47A-DB38A80E1EA6}"/>
              </a:ext>
            </a:extLst>
          </p:cNvPr>
          <p:cNvSpPr/>
          <p:nvPr/>
        </p:nvSpPr>
        <p:spPr>
          <a:xfrm rot="5400000" flipH="1">
            <a:off x="1656425" y="1737681"/>
            <a:ext cx="137370" cy="1032843"/>
          </a:xfrm>
          <a:prstGeom prst="righ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ight Bracket 6">
            <a:extLst>
              <a:ext uri="{FF2B5EF4-FFF2-40B4-BE49-F238E27FC236}">
                <a16:creationId xmlns:a16="http://schemas.microsoft.com/office/drawing/2014/main" id="{3E7500A6-33FB-E7BF-DA4B-52AD1EBDBEE5}"/>
              </a:ext>
            </a:extLst>
          </p:cNvPr>
          <p:cNvSpPr/>
          <p:nvPr/>
        </p:nvSpPr>
        <p:spPr>
          <a:xfrm rot="5400000">
            <a:off x="5918318" y="3222399"/>
            <a:ext cx="136618" cy="1059573"/>
          </a:xfrm>
          <a:prstGeom prst="righ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41AC098-7F9E-FF04-0697-5049A9A971E4}"/>
              </a:ext>
            </a:extLst>
          </p:cNvPr>
          <p:cNvSpPr txBox="1"/>
          <p:nvPr/>
        </p:nvSpPr>
        <p:spPr>
          <a:xfrm>
            <a:off x="1382308" y="2100967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se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401C162-EC7D-F5C1-BE19-61F380B1CD84}"/>
              </a:ext>
            </a:extLst>
          </p:cNvPr>
          <p:cNvSpPr txBox="1"/>
          <p:nvPr/>
        </p:nvSpPr>
        <p:spPr>
          <a:xfrm>
            <a:off x="5667130" y="3849085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sed</a:t>
            </a:r>
          </a:p>
        </p:txBody>
      </p:sp>
      <p:sp>
        <p:nvSpPr>
          <p:cNvPr id="10" name="Right Bracket 9">
            <a:extLst>
              <a:ext uri="{FF2B5EF4-FFF2-40B4-BE49-F238E27FC236}">
                <a16:creationId xmlns:a16="http://schemas.microsoft.com/office/drawing/2014/main" id="{14A0538B-8E8C-4B35-DF48-C5732EAA8E47}"/>
              </a:ext>
            </a:extLst>
          </p:cNvPr>
          <p:cNvSpPr/>
          <p:nvPr/>
        </p:nvSpPr>
        <p:spPr>
          <a:xfrm rot="5400000">
            <a:off x="9737270" y="3306468"/>
            <a:ext cx="136618" cy="1059573"/>
          </a:xfrm>
          <a:prstGeom prst="righ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432F3F6-D9BA-6166-CA86-5E8FC7B201D1}"/>
              </a:ext>
            </a:extLst>
          </p:cNvPr>
          <p:cNvSpPr txBox="1"/>
          <p:nvPr/>
        </p:nvSpPr>
        <p:spPr>
          <a:xfrm>
            <a:off x="9486082" y="3933154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se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9D57B56-B821-5C31-5317-405D7A383F41}"/>
              </a:ext>
            </a:extLst>
          </p:cNvPr>
          <p:cNvSpPr txBox="1"/>
          <p:nvPr/>
        </p:nvSpPr>
        <p:spPr>
          <a:xfrm>
            <a:off x="2646111" y="5504855"/>
            <a:ext cx="70514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mbranes were cut after transfer and stained with different antibodies.</a:t>
            </a:r>
          </a:p>
        </p:txBody>
      </p:sp>
    </p:spTree>
    <p:extLst>
      <p:ext uri="{BB962C8B-B14F-4D97-AF65-F5344CB8AC3E}">
        <p14:creationId xmlns:p14="http://schemas.microsoft.com/office/powerpoint/2010/main" val="35916247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A8A5DA3-1C26-9F45-93BB-B04DF58E7D6A}"/>
              </a:ext>
            </a:extLst>
          </p:cNvPr>
          <p:cNvSpPr txBox="1"/>
          <p:nvPr/>
        </p:nvSpPr>
        <p:spPr>
          <a:xfrm>
            <a:off x="4227988" y="178676"/>
            <a:ext cx="5606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Western Blot Image for Figure 2C (p21 and b-tubulin)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63C32701-4E32-29F4-D101-FA469EC04232}"/>
              </a:ext>
            </a:extLst>
          </p:cNvPr>
          <p:cNvGrpSpPr/>
          <p:nvPr/>
        </p:nvGrpSpPr>
        <p:grpSpPr>
          <a:xfrm>
            <a:off x="2325632" y="698307"/>
            <a:ext cx="6671224" cy="5461386"/>
            <a:chOff x="1936749" y="428624"/>
            <a:chExt cx="7604391" cy="6429600"/>
          </a:xfrm>
        </p:grpSpPr>
        <p:pic>
          <p:nvPicPr>
            <p:cNvPr id="4" name="Picture 3" descr="A picture containing text, electronics&#10;&#10;Description automatically generated">
              <a:extLst>
                <a:ext uri="{FF2B5EF4-FFF2-40B4-BE49-F238E27FC236}">
                  <a16:creationId xmlns:a16="http://schemas.microsoft.com/office/drawing/2014/main" id="{3B125FE8-CD12-8B04-0CBA-32DC4285FF9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36749" y="428624"/>
              <a:ext cx="7604391" cy="6429600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9981ECB0-25AC-675F-8A79-BDDA2537294A}"/>
                </a:ext>
              </a:extLst>
            </p:cNvPr>
            <p:cNvSpPr txBox="1"/>
            <p:nvPr/>
          </p:nvSpPr>
          <p:spPr>
            <a:xfrm>
              <a:off x="3331938" y="1979861"/>
              <a:ext cx="5469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250 </a:t>
              </a:r>
              <a:r>
                <a:rPr lang="en-US" sz="1000" dirty="0" err="1"/>
                <a:t>kD</a:t>
              </a:r>
              <a:endParaRPr lang="en-US" sz="1000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9C4E005-2D95-8673-F64C-02A14C08404A}"/>
                </a:ext>
              </a:extLst>
            </p:cNvPr>
            <p:cNvSpPr txBox="1"/>
            <p:nvPr/>
          </p:nvSpPr>
          <p:spPr>
            <a:xfrm>
              <a:off x="3417113" y="2072975"/>
              <a:ext cx="4106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150 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8C881C9-A07E-0F3F-442C-F2F92C13488C}"/>
                </a:ext>
              </a:extLst>
            </p:cNvPr>
            <p:cNvSpPr txBox="1"/>
            <p:nvPr/>
          </p:nvSpPr>
          <p:spPr>
            <a:xfrm>
              <a:off x="3414493" y="2195993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10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857440B-1702-1FE5-ABD4-DC0111D610F7}"/>
                </a:ext>
              </a:extLst>
            </p:cNvPr>
            <p:cNvSpPr txBox="1"/>
            <p:nvPr/>
          </p:nvSpPr>
          <p:spPr>
            <a:xfrm>
              <a:off x="3447355" y="2334931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5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FF598ED-A0E6-4166-F628-BBC1CF59F0A4}"/>
                </a:ext>
              </a:extLst>
            </p:cNvPr>
            <p:cNvSpPr txBox="1"/>
            <p:nvPr/>
          </p:nvSpPr>
          <p:spPr>
            <a:xfrm>
              <a:off x="3447355" y="2599756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3EA4CEA-F107-88B1-1B6C-F05FFB95E37D}"/>
                </a:ext>
              </a:extLst>
            </p:cNvPr>
            <p:cNvSpPr txBox="1"/>
            <p:nvPr/>
          </p:nvSpPr>
          <p:spPr>
            <a:xfrm>
              <a:off x="3447355" y="2831938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7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0BC1443-E972-CC08-162A-75F1E9B057E0}"/>
                </a:ext>
              </a:extLst>
            </p:cNvPr>
            <p:cNvSpPr txBox="1"/>
            <p:nvPr/>
          </p:nvSpPr>
          <p:spPr>
            <a:xfrm>
              <a:off x="3447355" y="3392246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25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661E96F-10C7-35E5-D4B4-E35F303A6DF5}"/>
                </a:ext>
              </a:extLst>
            </p:cNvPr>
            <p:cNvSpPr txBox="1"/>
            <p:nvPr/>
          </p:nvSpPr>
          <p:spPr>
            <a:xfrm>
              <a:off x="3447355" y="3631409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2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FACC759-1393-D1FC-EA6B-B3545E122FB8}"/>
                </a:ext>
              </a:extLst>
            </p:cNvPr>
            <p:cNvSpPr txBox="1"/>
            <p:nvPr/>
          </p:nvSpPr>
          <p:spPr>
            <a:xfrm>
              <a:off x="3474717" y="4052729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15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C2AF5BD-401F-917A-C4A4-566DFB84C912}"/>
                </a:ext>
              </a:extLst>
            </p:cNvPr>
            <p:cNvSpPr txBox="1"/>
            <p:nvPr/>
          </p:nvSpPr>
          <p:spPr>
            <a:xfrm>
              <a:off x="3513080" y="4736147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1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0D1CCA0-4EFA-75E4-3371-AE6A1AFD244B}"/>
                </a:ext>
              </a:extLst>
            </p:cNvPr>
            <p:cNvSpPr txBox="1"/>
            <p:nvPr/>
          </p:nvSpPr>
          <p:spPr>
            <a:xfrm>
              <a:off x="7569306" y="2319103"/>
              <a:ext cx="13315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eta tubulin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1485FA7-9CBD-D9CA-D6D3-3345845937C6}"/>
                </a:ext>
              </a:extLst>
            </p:cNvPr>
            <p:cNvSpPr txBox="1"/>
            <p:nvPr/>
          </p:nvSpPr>
          <p:spPr>
            <a:xfrm>
              <a:off x="7937606" y="3517225"/>
              <a:ext cx="5405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21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F2ADD7B2-540D-88E6-9973-5CC332024F32}"/>
              </a:ext>
            </a:extLst>
          </p:cNvPr>
          <p:cNvSpPr txBox="1"/>
          <p:nvPr/>
        </p:nvSpPr>
        <p:spPr>
          <a:xfrm rot="16200000">
            <a:off x="4419810" y="1711404"/>
            <a:ext cx="9632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cr</a:t>
            </a:r>
            <a:r>
              <a:rPr lang="en-US" dirty="0"/>
              <a:t> </a:t>
            </a:r>
            <a:r>
              <a:rPr lang="en-US" dirty="0" err="1"/>
              <a:t>Cont</a:t>
            </a:r>
            <a:endParaRPr 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9943D91-E98F-0B55-145A-00DD2A8F4139}"/>
              </a:ext>
            </a:extLst>
          </p:cNvPr>
          <p:cNvSpPr txBox="1"/>
          <p:nvPr/>
        </p:nvSpPr>
        <p:spPr>
          <a:xfrm rot="16200000">
            <a:off x="4869119" y="1768053"/>
            <a:ext cx="84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ieNOS</a:t>
            </a:r>
            <a:endParaRPr lang="en-US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9B7590C-0190-7842-5295-73C027EFE33F}"/>
              </a:ext>
            </a:extLst>
          </p:cNvPr>
          <p:cNvSpPr txBox="1"/>
          <p:nvPr/>
        </p:nvSpPr>
        <p:spPr>
          <a:xfrm rot="16200000">
            <a:off x="5254627" y="1711404"/>
            <a:ext cx="9632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cr</a:t>
            </a:r>
            <a:r>
              <a:rPr lang="en-US" dirty="0"/>
              <a:t> </a:t>
            </a:r>
            <a:r>
              <a:rPr lang="en-US" dirty="0" err="1"/>
              <a:t>Cont</a:t>
            </a:r>
            <a:endParaRPr 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5918C3E-E0B5-46F3-271E-7D6AA1687831}"/>
              </a:ext>
            </a:extLst>
          </p:cNvPr>
          <p:cNvSpPr txBox="1"/>
          <p:nvPr/>
        </p:nvSpPr>
        <p:spPr>
          <a:xfrm rot="16200000">
            <a:off x="5703936" y="1768053"/>
            <a:ext cx="84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ieNOS</a:t>
            </a:r>
            <a:endParaRPr lang="en-US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2E9445D-6F35-FC0F-3DBA-1BB947A1B1BB}"/>
              </a:ext>
            </a:extLst>
          </p:cNvPr>
          <p:cNvSpPr txBox="1"/>
          <p:nvPr/>
        </p:nvSpPr>
        <p:spPr>
          <a:xfrm rot="16200000">
            <a:off x="6089444" y="1711404"/>
            <a:ext cx="9632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cr</a:t>
            </a:r>
            <a:r>
              <a:rPr lang="en-US" dirty="0"/>
              <a:t> </a:t>
            </a:r>
            <a:r>
              <a:rPr lang="en-US" dirty="0" err="1"/>
              <a:t>Cont</a:t>
            </a:r>
            <a:endParaRPr 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210BC53-5E1D-265F-B6C2-62CF547706F3}"/>
              </a:ext>
            </a:extLst>
          </p:cNvPr>
          <p:cNvSpPr txBox="1"/>
          <p:nvPr/>
        </p:nvSpPr>
        <p:spPr>
          <a:xfrm rot="16200000">
            <a:off x="6538753" y="1768053"/>
            <a:ext cx="84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ieNOS</a:t>
            </a:r>
            <a:endParaRPr lang="en-US" dirty="0"/>
          </a:p>
        </p:txBody>
      </p:sp>
      <p:sp>
        <p:nvSpPr>
          <p:cNvPr id="23" name="Right Bracket 22">
            <a:extLst>
              <a:ext uri="{FF2B5EF4-FFF2-40B4-BE49-F238E27FC236}">
                <a16:creationId xmlns:a16="http://schemas.microsoft.com/office/drawing/2014/main" id="{74FD8978-0170-E2FA-458C-88E477899E76}"/>
              </a:ext>
            </a:extLst>
          </p:cNvPr>
          <p:cNvSpPr/>
          <p:nvPr/>
        </p:nvSpPr>
        <p:spPr>
          <a:xfrm rot="5400000">
            <a:off x="5124221" y="3450975"/>
            <a:ext cx="118786" cy="735906"/>
          </a:xfrm>
          <a:prstGeom prst="righ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70E1BEE-73FF-F4C8-1DCA-BA77FA07B372}"/>
              </a:ext>
            </a:extLst>
          </p:cNvPr>
          <p:cNvSpPr txBox="1"/>
          <p:nvPr/>
        </p:nvSpPr>
        <p:spPr>
          <a:xfrm>
            <a:off x="4854036" y="3987841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sed</a:t>
            </a:r>
          </a:p>
        </p:txBody>
      </p:sp>
      <p:sp>
        <p:nvSpPr>
          <p:cNvPr id="25" name="Right Bracket 24">
            <a:extLst>
              <a:ext uri="{FF2B5EF4-FFF2-40B4-BE49-F238E27FC236}">
                <a16:creationId xmlns:a16="http://schemas.microsoft.com/office/drawing/2014/main" id="{10BAC112-83CE-55FA-785C-6DB6BF437798}"/>
              </a:ext>
            </a:extLst>
          </p:cNvPr>
          <p:cNvSpPr/>
          <p:nvPr/>
        </p:nvSpPr>
        <p:spPr>
          <a:xfrm rot="5400000">
            <a:off x="5085846" y="2415607"/>
            <a:ext cx="118786" cy="735906"/>
          </a:xfrm>
          <a:prstGeom prst="righ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C6F3050-3C04-4C49-4427-C289204AEF94}"/>
              </a:ext>
            </a:extLst>
          </p:cNvPr>
          <p:cNvSpPr txBox="1"/>
          <p:nvPr/>
        </p:nvSpPr>
        <p:spPr>
          <a:xfrm>
            <a:off x="4815661" y="2952473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sed</a:t>
            </a:r>
          </a:p>
        </p:txBody>
      </p:sp>
    </p:spTree>
    <p:extLst>
      <p:ext uri="{BB962C8B-B14F-4D97-AF65-F5344CB8AC3E}">
        <p14:creationId xmlns:p14="http://schemas.microsoft.com/office/powerpoint/2010/main" val="24682332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B303DCC-D847-044C-2410-1B9A33D1EA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51070" y="614423"/>
            <a:ext cx="7302500" cy="46355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41437A0-805B-E4E5-3A8C-93C485E2B3D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6006" y="614423"/>
            <a:ext cx="4025900" cy="46863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D29F483-2B15-E84F-243D-6BC539F0C7A2}"/>
              </a:ext>
            </a:extLst>
          </p:cNvPr>
          <p:cNvSpPr txBox="1"/>
          <p:nvPr/>
        </p:nvSpPr>
        <p:spPr>
          <a:xfrm>
            <a:off x="4223981" y="84083"/>
            <a:ext cx="53213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Western Blot Image for Figure 3A (AKT and p-AKT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BF6BAAB-88C5-4CB3-1DDF-48C024BA8FDB}"/>
              </a:ext>
            </a:extLst>
          </p:cNvPr>
          <p:cNvSpPr txBox="1"/>
          <p:nvPr/>
        </p:nvSpPr>
        <p:spPr>
          <a:xfrm>
            <a:off x="1668649" y="5809655"/>
            <a:ext cx="80534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embranes were cut after transfer and stained with different antibodies. Later they were3 exposed for 2 time points (exposure 1 and 2)</a:t>
            </a:r>
          </a:p>
        </p:txBody>
      </p:sp>
      <p:sp>
        <p:nvSpPr>
          <p:cNvPr id="6" name="Right Bracket 5">
            <a:extLst>
              <a:ext uri="{FF2B5EF4-FFF2-40B4-BE49-F238E27FC236}">
                <a16:creationId xmlns:a16="http://schemas.microsoft.com/office/drawing/2014/main" id="{1A65901B-F6DA-95F5-71AE-7E8BD329DDE7}"/>
              </a:ext>
            </a:extLst>
          </p:cNvPr>
          <p:cNvSpPr/>
          <p:nvPr/>
        </p:nvSpPr>
        <p:spPr>
          <a:xfrm rot="5400000">
            <a:off x="6229843" y="1870353"/>
            <a:ext cx="165210" cy="744262"/>
          </a:xfrm>
          <a:prstGeom prst="righ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5145D8A-AA28-924A-4FC1-53B8E8DF4E35}"/>
              </a:ext>
            </a:extLst>
          </p:cNvPr>
          <p:cNvSpPr txBox="1"/>
          <p:nvPr/>
        </p:nvSpPr>
        <p:spPr>
          <a:xfrm>
            <a:off x="6056014" y="2262023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sed</a:t>
            </a:r>
          </a:p>
        </p:txBody>
      </p:sp>
      <p:sp>
        <p:nvSpPr>
          <p:cNvPr id="8" name="Right Bracket 7">
            <a:extLst>
              <a:ext uri="{FF2B5EF4-FFF2-40B4-BE49-F238E27FC236}">
                <a16:creationId xmlns:a16="http://schemas.microsoft.com/office/drawing/2014/main" id="{3CC10040-C17F-665D-8C09-3FDC229D621E}"/>
              </a:ext>
            </a:extLst>
          </p:cNvPr>
          <p:cNvSpPr/>
          <p:nvPr/>
        </p:nvSpPr>
        <p:spPr>
          <a:xfrm rot="5400000">
            <a:off x="2073001" y="1952958"/>
            <a:ext cx="165210" cy="744262"/>
          </a:xfrm>
          <a:prstGeom prst="righ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30EBE67-8535-5DC3-96AD-A32F419955AF}"/>
              </a:ext>
            </a:extLst>
          </p:cNvPr>
          <p:cNvSpPr txBox="1"/>
          <p:nvPr/>
        </p:nvSpPr>
        <p:spPr>
          <a:xfrm>
            <a:off x="1899172" y="2344628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sed</a:t>
            </a:r>
          </a:p>
        </p:txBody>
      </p:sp>
    </p:spTree>
    <p:extLst>
      <p:ext uri="{BB962C8B-B14F-4D97-AF65-F5344CB8AC3E}">
        <p14:creationId xmlns:p14="http://schemas.microsoft.com/office/powerpoint/2010/main" val="12348134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6C2F285-3F0E-A6B8-3439-46BF14615B70}"/>
              </a:ext>
            </a:extLst>
          </p:cNvPr>
          <p:cNvSpPr txBox="1"/>
          <p:nvPr/>
        </p:nvSpPr>
        <p:spPr>
          <a:xfrm>
            <a:off x="4227988" y="185964"/>
            <a:ext cx="53053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Western Blot Image for Figure 3A (ERK and p-ERK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335B944-8967-3BA2-956F-81B1F921B7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6345" y="718207"/>
            <a:ext cx="8735410" cy="524701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EACACD7-3A60-6CAD-2B5C-E9C85FE1AD3E}"/>
              </a:ext>
            </a:extLst>
          </p:cNvPr>
          <p:cNvSpPr txBox="1"/>
          <p:nvPr/>
        </p:nvSpPr>
        <p:spPr>
          <a:xfrm>
            <a:off x="1668649" y="5809655"/>
            <a:ext cx="80534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embranes were cut after transfer and stained with different antibodies. Later they were3 exposed for 2 time points (exposure 1 and 2)</a:t>
            </a:r>
          </a:p>
        </p:txBody>
      </p:sp>
      <p:sp>
        <p:nvSpPr>
          <p:cNvPr id="9" name="Right Bracket 8">
            <a:extLst>
              <a:ext uri="{FF2B5EF4-FFF2-40B4-BE49-F238E27FC236}">
                <a16:creationId xmlns:a16="http://schemas.microsoft.com/office/drawing/2014/main" id="{B906BBA5-B36B-762D-8BEC-EC78F2DC21B3}"/>
              </a:ext>
            </a:extLst>
          </p:cNvPr>
          <p:cNvSpPr/>
          <p:nvPr/>
        </p:nvSpPr>
        <p:spPr>
          <a:xfrm rot="5400000" flipH="1">
            <a:off x="7436347" y="2919527"/>
            <a:ext cx="148560" cy="828346"/>
          </a:xfrm>
          <a:prstGeom prst="righ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9125E5E-5423-3B04-B026-DAA27573C437}"/>
              </a:ext>
            </a:extLst>
          </p:cNvPr>
          <p:cNvSpPr txBox="1"/>
          <p:nvPr/>
        </p:nvSpPr>
        <p:spPr>
          <a:xfrm>
            <a:off x="7191131" y="2933597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sed</a:t>
            </a:r>
          </a:p>
        </p:txBody>
      </p:sp>
      <p:sp>
        <p:nvSpPr>
          <p:cNvPr id="14" name="Right Bracket 13">
            <a:extLst>
              <a:ext uri="{FF2B5EF4-FFF2-40B4-BE49-F238E27FC236}">
                <a16:creationId xmlns:a16="http://schemas.microsoft.com/office/drawing/2014/main" id="{4ED00DBF-BD06-4BAC-E8BE-D22772B06B7F}"/>
              </a:ext>
            </a:extLst>
          </p:cNvPr>
          <p:cNvSpPr/>
          <p:nvPr/>
        </p:nvSpPr>
        <p:spPr>
          <a:xfrm rot="16200000" flipH="1">
            <a:off x="2953683" y="1674052"/>
            <a:ext cx="148560" cy="828346"/>
          </a:xfrm>
          <a:prstGeom prst="righ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A154B84-B281-88F5-DE4D-E8BF423D17D9}"/>
              </a:ext>
            </a:extLst>
          </p:cNvPr>
          <p:cNvSpPr txBox="1"/>
          <p:nvPr/>
        </p:nvSpPr>
        <p:spPr>
          <a:xfrm>
            <a:off x="2666854" y="2137441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sed</a:t>
            </a:r>
          </a:p>
        </p:txBody>
      </p:sp>
    </p:spTree>
    <p:extLst>
      <p:ext uri="{BB962C8B-B14F-4D97-AF65-F5344CB8AC3E}">
        <p14:creationId xmlns:p14="http://schemas.microsoft.com/office/powerpoint/2010/main" val="38037729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56161A6-E923-9EF5-8F46-60CA1C3C324E}"/>
              </a:ext>
            </a:extLst>
          </p:cNvPr>
          <p:cNvSpPr txBox="1"/>
          <p:nvPr/>
        </p:nvSpPr>
        <p:spPr>
          <a:xfrm>
            <a:off x="4227988" y="185964"/>
            <a:ext cx="44621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Western Blot Image for Figure 3B and 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CC4FB17-EDBB-F907-6CA4-02A203F937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76299"/>
            <a:ext cx="5884470" cy="510539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38ECE38D-B3A9-D41E-C2CE-8AB8E5D417E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77581" y="876300"/>
            <a:ext cx="6019800" cy="51054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CE4719D-9A59-E796-874C-C2121ADECB1F}"/>
              </a:ext>
            </a:extLst>
          </p:cNvPr>
          <p:cNvSpPr txBox="1"/>
          <p:nvPr/>
        </p:nvSpPr>
        <p:spPr>
          <a:xfrm rot="16200000">
            <a:off x="873421" y="2267458"/>
            <a:ext cx="9632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cr</a:t>
            </a:r>
            <a:r>
              <a:rPr lang="en-US" dirty="0"/>
              <a:t> </a:t>
            </a:r>
            <a:r>
              <a:rPr lang="en-US" dirty="0" err="1"/>
              <a:t>Cont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D4141AF-1929-BF99-5274-929C89C7E012}"/>
              </a:ext>
            </a:extLst>
          </p:cNvPr>
          <p:cNvSpPr txBox="1"/>
          <p:nvPr/>
        </p:nvSpPr>
        <p:spPr>
          <a:xfrm rot="16200000">
            <a:off x="1433943" y="2324107"/>
            <a:ext cx="84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ieNOS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89469D7-13B8-9D3D-EBDC-3C8E7439C177}"/>
              </a:ext>
            </a:extLst>
          </p:cNvPr>
          <p:cNvSpPr txBox="1"/>
          <p:nvPr/>
        </p:nvSpPr>
        <p:spPr>
          <a:xfrm rot="16200000">
            <a:off x="1893591" y="2267458"/>
            <a:ext cx="9632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cr</a:t>
            </a:r>
            <a:r>
              <a:rPr lang="en-US" dirty="0"/>
              <a:t> </a:t>
            </a:r>
            <a:r>
              <a:rPr lang="en-US" dirty="0" err="1"/>
              <a:t>Cont</a:t>
            </a:r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F8BEA07-A667-2B2F-AEDA-21A10EDE56FB}"/>
              </a:ext>
            </a:extLst>
          </p:cNvPr>
          <p:cNvSpPr txBox="1"/>
          <p:nvPr/>
        </p:nvSpPr>
        <p:spPr>
          <a:xfrm rot="16200000">
            <a:off x="2404684" y="2324107"/>
            <a:ext cx="84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ieNOS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1C823BA-A4D4-2579-00BE-2B6994F68135}"/>
              </a:ext>
            </a:extLst>
          </p:cNvPr>
          <p:cNvSpPr txBox="1"/>
          <p:nvPr/>
        </p:nvSpPr>
        <p:spPr>
          <a:xfrm rot="16200000">
            <a:off x="2876689" y="2267458"/>
            <a:ext cx="9632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cr</a:t>
            </a:r>
            <a:r>
              <a:rPr lang="en-US" dirty="0"/>
              <a:t> </a:t>
            </a:r>
            <a:r>
              <a:rPr lang="en-US" dirty="0" err="1"/>
              <a:t>Cont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D23483D-FE0F-8513-DEF2-46E48BF2E2C7}"/>
              </a:ext>
            </a:extLst>
          </p:cNvPr>
          <p:cNvSpPr txBox="1"/>
          <p:nvPr/>
        </p:nvSpPr>
        <p:spPr>
          <a:xfrm rot="16200000">
            <a:off x="3350712" y="2324107"/>
            <a:ext cx="84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ieNOS</a:t>
            </a:r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C4246BB-F4CC-5461-0B81-38CFEC0B22D8}"/>
              </a:ext>
            </a:extLst>
          </p:cNvPr>
          <p:cNvSpPr txBox="1"/>
          <p:nvPr/>
        </p:nvSpPr>
        <p:spPr>
          <a:xfrm rot="16200000">
            <a:off x="3791188" y="2267459"/>
            <a:ext cx="9632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cr</a:t>
            </a:r>
            <a:r>
              <a:rPr lang="en-US" dirty="0"/>
              <a:t> </a:t>
            </a:r>
            <a:r>
              <a:rPr lang="en-US" dirty="0" err="1"/>
              <a:t>Cont</a:t>
            </a:r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E042ACF-8E56-FD1A-4860-D24E5006B259}"/>
              </a:ext>
            </a:extLst>
          </p:cNvPr>
          <p:cNvSpPr txBox="1"/>
          <p:nvPr/>
        </p:nvSpPr>
        <p:spPr>
          <a:xfrm rot="16200000">
            <a:off x="4265211" y="2324108"/>
            <a:ext cx="84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ieNOS</a:t>
            </a:r>
            <a:endParaRPr lang="en-US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A7A8ACB-3EB0-2383-685B-25402D30C6CA}"/>
              </a:ext>
            </a:extLst>
          </p:cNvPr>
          <p:cNvSpPr txBox="1"/>
          <p:nvPr/>
        </p:nvSpPr>
        <p:spPr>
          <a:xfrm rot="16200000">
            <a:off x="7020226" y="2535472"/>
            <a:ext cx="9632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cr</a:t>
            </a:r>
            <a:r>
              <a:rPr lang="en-US" dirty="0"/>
              <a:t> </a:t>
            </a:r>
            <a:r>
              <a:rPr lang="en-US" dirty="0" err="1"/>
              <a:t>Cont</a:t>
            </a:r>
            <a:endParaRPr lang="en-U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0B56ED3-B199-212E-DBFB-F668AA54149E}"/>
              </a:ext>
            </a:extLst>
          </p:cNvPr>
          <p:cNvSpPr txBox="1"/>
          <p:nvPr/>
        </p:nvSpPr>
        <p:spPr>
          <a:xfrm rot="16200000">
            <a:off x="7412583" y="2592121"/>
            <a:ext cx="84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ieNOS</a:t>
            </a:r>
            <a:endParaRPr lang="en-US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D21634C-36BE-15D5-21FF-AFEF625C214B}"/>
              </a:ext>
            </a:extLst>
          </p:cNvPr>
          <p:cNvSpPr txBox="1"/>
          <p:nvPr/>
        </p:nvSpPr>
        <p:spPr>
          <a:xfrm rot="16200000">
            <a:off x="7735599" y="2535472"/>
            <a:ext cx="9632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cr</a:t>
            </a:r>
            <a:r>
              <a:rPr lang="en-US" dirty="0"/>
              <a:t> </a:t>
            </a:r>
            <a:r>
              <a:rPr lang="en-US" dirty="0" err="1"/>
              <a:t>Cont</a:t>
            </a:r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5DD3385-DE34-5637-884E-689AB0BA505D}"/>
              </a:ext>
            </a:extLst>
          </p:cNvPr>
          <p:cNvSpPr txBox="1"/>
          <p:nvPr/>
        </p:nvSpPr>
        <p:spPr>
          <a:xfrm rot="16200000">
            <a:off x="8162608" y="2592121"/>
            <a:ext cx="84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ieNOS</a:t>
            </a:r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9499D6A-B8D3-9B2D-2F1B-89E1C658EDB4}"/>
              </a:ext>
            </a:extLst>
          </p:cNvPr>
          <p:cNvSpPr txBox="1"/>
          <p:nvPr/>
        </p:nvSpPr>
        <p:spPr>
          <a:xfrm rot="16200000">
            <a:off x="8508489" y="2535472"/>
            <a:ext cx="9632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cr</a:t>
            </a:r>
            <a:r>
              <a:rPr lang="en-US" dirty="0"/>
              <a:t> </a:t>
            </a:r>
            <a:r>
              <a:rPr lang="en-US" dirty="0" err="1"/>
              <a:t>Cont</a:t>
            </a:r>
            <a:endParaRPr 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BAAB7AD-A49F-B119-85B6-02BF7F6DC169}"/>
              </a:ext>
            </a:extLst>
          </p:cNvPr>
          <p:cNvSpPr txBox="1"/>
          <p:nvPr/>
        </p:nvSpPr>
        <p:spPr>
          <a:xfrm rot="16200000">
            <a:off x="8929960" y="2592121"/>
            <a:ext cx="84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ieNOS</a:t>
            </a:r>
            <a:endParaRPr lang="en-US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F0D63E3-6C2A-AEFF-D0F3-ADF365D51E68}"/>
              </a:ext>
            </a:extLst>
          </p:cNvPr>
          <p:cNvSpPr txBox="1"/>
          <p:nvPr/>
        </p:nvSpPr>
        <p:spPr>
          <a:xfrm rot="16200000">
            <a:off x="9244312" y="2535473"/>
            <a:ext cx="9632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cr</a:t>
            </a:r>
            <a:r>
              <a:rPr lang="en-US" dirty="0"/>
              <a:t> </a:t>
            </a:r>
            <a:r>
              <a:rPr lang="en-US" dirty="0" err="1"/>
              <a:t>Cont</a:t>
            </a:r>
            <a:endParaRPr 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E82C576-52A7-CE20-A6B8-2CDBD16568B1}"/>
              </a:ext>
            </a:extLst>
          </p:cNvPr>
          <p:cNvSpPr txBox="1"/>
          <p:nvPr/>
        </p:nvSpPr>
        <p:spPr>
          <a:xfrm rot="16200000">
            <a:off x="9665783" y="2592122"/>
            <a:ext cx="84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ieNOS</a:t>
            </a:r>
            <a:endParaRPr lang="en-US" dirty="0"/>
          </a:p>
        </p:txBody>
      </p:sp>
      <p:sp>
        <p:nvSpPr>
          <p:cNvPr id="21" name="Right Bracket 20">
            <a:extLst>
              <a:ext uri="{FF2B5EF4-FFF2-40B4-BE49-F238E27FC236}">
                <a16:creationId xmlns:a16="http://schemas.microsoft.com/office/drawing/2014/main" id="{27F3711C-9A6F-4978-31F6-9F1BEC22DD23}"/>
              </a:ext>
            </a:extLst>
          </p:cNvPr>
          <p:cNvSpPr/>
          <p:nvPr/>
        </p:nvSpPr>
        <p:spPr>
          <a:xfrm rot="5400000">
            <a:off x="9910095" y="3193169"/>
            <a:ext cx="118786" cy="735906"/>
          </a:xfrm>
          <a:prstGeom prst="righ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5C24669-0121-7205-0FC0-6B3E2403E118}"/>
              </a:ext>
            </a:extLst>
          </p:cNvPr>
          <p:cNvSpPr txBox="1"/>
          <p:nvPr/>
        </p:nvSpPr>
        <p:spPr>
          <a:xfrm>
            <a:off x="9660930" y="3540849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sed</a:t>
            </a:r>
          </a:p>
        </p:txBody>
      </p:sp>
      <p:sp>
        <p:nvSpPr>
          <p:cNvPr id="23" name="Right Bracket 22">
            <a:extLst>
              <a:ext uri="{FF2B5EF4-FFF2-40B4-BE49-F238E27FC236}">
                <a16:creationId xmlns:a16="http://schemas.microsoft.com/office/drawing/2014/main" id="{D145110A-41F0-C9E2-461E-2045300600AB}"/>
              </a:ext>
            </a:extLst>
          </p:cNvPr>
          <p:cNvSpPr/>
          <p:nvPr/>
        </p:nvSpPr>
        <p:spPr>
          <a:xfrm rot="5400000">
            <a:off x="4579009" y="2931513"/>
            <a:ext cx="111937" cy="883037"/>
          </a:xfrm>
          <a:prstGeom prst="righ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EA15AE7-E79E-982F-9D45-F43FCA87065A}"/>
              </a:ext>
            </a:extLst>
          </p:cNvPr>
          <p:cNvSpPr txBox="1"/>
          <p:nvPr/>
        </p:nvSpPr>
        <p:spPr>
          <a:xfrm>
            <a:off x="4315916" y="3356183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sed</a:t>
            </a:r>
          </a:p>
        </p:txBody>
      </p:sp>
      <p:sp>
        <p:nvSpPr>
          <p:cNvPr id="28" name="Right Bracket 27">
            <a:extLst>
              <a:ext uri="{FF2B5EF4-FFF2-40B4-BE49-F238E27FC236}">
                <a16:creationId xmlns:a16="http://schemas.microsoft.com/office/drawing/2014/main" id="{AE0E9DC0-B9A7-4FFE-3293-AFE720E1EA53}"/>
              </a:ext>
            </a:extLst>
          </p:cNvPr>
          <p:cNvSpPr/>
          <p:nvPr/>
        </p:nvSpPr>
        <p:spPr>
          <a:xfrm rot="5400000">
            <a:off x="3535033" y="3737304"/>
            <a:ext cx="111937" cy="883037"/>
          </a:xfrm>
          <a:prstGeom prst="righ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2CC531E-3073-8494-55FA-2A795942D66C}"/>
              </a:ext>
            </a:extLst>
          </p:cNvPr>
          <p:cNvSpPr txBox="1"/>
          <p:nvPr/>
        </p:nvSpPr>
        <p:spPr>
          <a:xfrm>
            <a:off x="3271940" y="4161974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sed</a:t>
            </a:r>
          </a:p>
        </p:txBody>
      </p:sp>
      <p:sp>
        <p:nvSpPr>
          <p:cNvPr id="30" name="Right Bracket 29">
            <a:extLst>
              <a:ext uri="{FF2B5EF4-FFF2-40B4-BE49-F238E27FC236}">
                <a16:creationId xmlns:a16="http://schemas.microsoft.com/office/drawing/2014/main" id="{4F2A7159-9484-A8FF-DCFC-5CDDA3895B4A}"/>
              </a:ext>
            </a:extLst>
          </p:cNvPr>
          <p:cNvSpPr/>
          <p:nvPr/>
        </p:nvSpPr>
        <p:spPr>
          <a:xfrm rot="5400000">
            <a:off x="9114281" y="3720455"/>
            <a:ext cx="111937" cy="883037"/>
          </a:xfrm>
          <a:prstGeom prst="righ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A21028D-CE3C-0D9D-F794-DB2687AA92FE}"/>
              </a:ext>
            </a:extLst>
          </p:cNvPr>
          <p:cNvSpPr txBox="1"/>
          <p:nvPr/>
        </p:nvSpPr>
        <p:spPr>
          <a:xfrm>
            <a:off x="8851188" y="4145125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sed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74A24FD-A0E0-6C2A-3940-E689F128864A}"/>
              </a:ext>
            </a:extLst>
          </p:cNvPr>
          <p:cNvSpPr txBox="1"/>
          <p:nvPr/>
        </p:nvSpPr>
        <p:spPr>
          <a:xfrm>
            <a:off x="176923" y="1724296"/>
            <a:ext cx="5469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50 </a:t>
            </a:r>
            <a:r>
              <a:rPr lang="en-US" sz="1000" dirty="0" err="1"/>
              <a:t>kD</a:t>
            </a:r>
            <a:endParaRPr lang="en-US" sz="10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7E20813-305C-1A4F-4128-4F3CD4F5A761}"/>
              </a:ext>
            </a:extLst>
          </p:cNvPr>
          <p:cNvSpPr txBox="1"/>
          <p:nvPr/>
        </p:nvSpPr>
        <p:spPr>
          <a:xfrm>
            <a:off x="262098" y="1922513"/>
            <a:ext cx="4106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0 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022A78F-4E9E-BA08-6D7D-A97789916004}"/>
              </a:ext>
            </a:extLst>
          </p:cNvPr>
          <p:cNvSpPr txBox="1"/>
          <p:nvPr/>
        </p:nvSpPr>
        <p:spPr>
          <a:xfrm>
            <a:off x="259478" y="2224206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A283FF2-F6B3-EA49-0C0C-63C82BD08A5D}"/>
              </a:ext>
            </a:extLst>
          </p:cNvPr>
          <p:cNvSpPr txBox="1"/>
          <p:nvPr/>
        </p:nvSpPr>
        <p:spPr>
          <a:xfrm>
            <a:off x="292340" y="257335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75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9B35D58-3C8A-DCF2-1B0E-A5E2A2CAA7CB}"/>
              </a:ext>
            </a:extLst>
          </p:cNvPr>
          <p:cNvSpPr txBox="1"/>
          <p:nvPr/>
        </p:nvSpPr>
        <p:spPr>
          <a:xfrm>
            <a:off x="292340" y="3258588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A111C4F-FF25-AA92-0EC2-A0EF1534E6AC}"/>
              </a:ext>
            </a:extLst>
          </p:cNvPr>
          <p:cNvSpPr txBox="1"/>
          <p:nvPr/>
        </p:nvSpPr>
        <p:spPr>
          <a:xfrm>
            <a:off x="292340" y="3974245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7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9C78D87-517B-2350-BB74-4FB53C4999BA}"/>
              </a:ext>
            </a:extLst>
          </p:cNvPr>
          <p:cNvSpPr txBox="1"/>
          <p:nvPr/>
        </p:nvSpPr>
        <p:spPr>
          <a:xfrm>
            <a:off x="292340" y="4471494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5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A7DE32B-90A4-2C85-A0FF-BA4453BC4F03}"/>
              </a:ext>
            </a:extLst>
          </p:cNvPr>
          <p:cNvSpPr txBox="1"/>
          <p:nvPr/>
        </p:nvSpPr>
        <p:spPr>
          <a:xfrm>
            <a:off x="6508279" y="2224206"/>
            <a:ext cx="5469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50 </a:t>
            </a:r>
            <a:r>
              <a:rPr lang="en-US" sz="1000" dirty="0" err="1"/>
              <a:t>kD</a:t>
            </a:r>
            <a:endParaRPr lang="en-US" sz="10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6EE6D5C-8C4B-1431-0C39-8165292821C7}"/>
              </a:ext>
            </a:extLst>
          </p:cNvPr>
          <p:cNvSpPr txBox="1"/>
          <p:nvPr/>
        </p:nvSpPr>
        <p:spPr>
          <a:xfrm>
            <a:off x="6593454" y="2422423"/>
            <a:ext cx="4106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0 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FCD5506-C064-6F0E-8491-5D2EB35A2BAC}"/>
              </a:ext>
            </a:extLst>
          </p:cNvPr>
          <p:cNvSpPr txBox="1"/>
          <p:nvPr/>
        </p:nvSpPr>
        <p:spPr>
          <a:xfrm>
            <a:off x="6590834" y="2650543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5403331-BCA4-B574-7C7B-D6F31766545A}"/>
              </a:ext>
            </a:extLst>
          </p:cNvPr>
          <p:cNvSpPr txBox="1"/>
          <p:nvPr/>
        </p:nvSpPr>
        <p:spPr>
          <a:xfrm>
            <a:off x="6623696" y="2905097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75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1F4EC02-2414-D771-89B6-E18DD2FA5954}"/>
              </a:ext>
            </a:extLst>
          </p:cNvPr>
          <p:cNvSpPr txBox="1"/>
          <p:nvPr/>
        </p:nvSpPr>
        <p:spPr>
          <a:xfrm>
            <a:off x="6623696" y="3474720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A8D12EA-AEA0-C43B-86AC-E1606128B2C7}"/>
              </a:ext>
            </a:extLst>
          </p:cNvPr>
          <p:cNvSpPr txBox="1"/>
          <p:nvPr/>
        </p:nvSpPr>
        <p:spPr>
          <a:xfrm>
            <a:off x="6623696" y="4011700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7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5ED3A6D-6BEA-4E3C-E67F-FE596D3BE018}"/>
              </a:ext>
            </a:extLst>
          </p:cNvPr>
          <p:cNvSpPr txBox="1"/>
          <p:nvPr/>
        </p:nvSpPr>
        <p:spPr>
          <a:xfrm>
            <a:off x="6623696" y="4361805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5</a:t>
            </a:r>
          </a:p>
        </p:txBody>
      </p:sp>
    </p:spTree>
    <p:extLst>
      <p:ext uri="{BB962C8B-B14F-4D97-AF65-F5344CB8AC3E}">
        <p14:creationId xmlns:p14="http://schemas.microsoft.com/office/powerpoint/2010/main" val="18598140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210</Words>
  <Application>Microsoft Macintosh PowerPoint</Application>
  <PresentationFormat>Widescreen</PresentationFormat>
  <Paragraphs>72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uhan Bu</dc:creator>
  <cp:lastModifiedBy>Krishna Singh</cp:lastModifiedBy>
  <cp:revision>20</cp:revision>
  <dcterms:created xsi:type="dcterms:W3CDTF">2022-07-22T13:21:25Z</dcterms:created>
  <dcterms:modified xsi:type="dcterms:W3CDTF">2022-07-22T17:13:30Z</dcterms:modified>
</cp:coreProperties>
</file>